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6" r:id="rId2"/>
  </p:sldIdLst>
  <p:sldSz cx="6858000" cy="9144000" type="screen4x3"/>
  <p:notesSz cx="9939338" cy="68072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522B7-1C83-8829-CACA-9FB753ED7AE0}" name="崇史 黒江" initials="崇史" userId="a22cf01eb3c45466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石井源一郎" initials="石井" lastIdx="22" clrIdx="0"/>
  <p:cmAuthor id="7" name="石井 源一郎" initials="石井" lastIdx="43" clrIdx="7"/>
  <p:cmAuthor id="1" name="tomo" initials="t" lastIdx="7" clrIdx="1"/>
  <p:cmAuthor id="8" name="ISHII" initials="I" lastIdx="38" clrIdx="8">
    <p:extLst>
      <p:ext uri="{19B8F6BF-5375-455C-9EA6-DF929625EA0E}">
        <p15:presenceInfo xmlns:p15="http://schemas.microsoft.com/office/powerpoint/2012/main" userId="ISHII" providerId="None"/>
      </p:ext>
    </p:extLst>
  </p:cmAuthor>
  <p:cmAuthor id="2" name="石井源一郎" initials="石井源一郎" lastIdx="5" clrIdx="2"/>
  <p:cmAuthor id="3" name="ishiiP2292" initials="i" lastIdx="10" clrIdx="3"/>
  <p:cmAuthor id="4" name="TI" initials="T" lastIdx="1" clrIdx="4"/>
  <p:cmAuthor id="5" name="石井　源一郎" initials="石井　源一郎" lastIdx="63" clrIdx="5"/>
  <p:cmAuthor id="6" name="崇史 黒江" initials="崇史" lastIdx="155" clrIdx="6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17" autoAdjust="0"/>
    <p:restoredTop sz="96242" autoAdjust="0"/>
  </p:normalViewPr>
  <p:slideViewPr>
    <p:cSldViewPr>
      <p:cViewPr varScale="1">
        <p:scale>
          <a:sx n="42" d="100"/>
          <a:sy n="42" d="100"/>
        </p:scale>
        <p:origin x="2456" y="44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4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r">
              <a:defRPr sz="1200"/>
            </a:lvl1pPr>
          </a:lstStyle>
          <a:p>
            <a:fld id="{18D96FBF-3B6B-4E7C-B033-A5D0AF30607C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13200" y="509588"/>
            <a:ext cx="1912938" cy="25542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29" tIns="46115" rIns="92229" bIns="4611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5" y="3233422"/>
            <a:ext cx="7951470" cy="3063240"/>
          </a:xfrm>
          <a:prstGeom prst="rect">
            <a:avLst/>
          </a:prstGeom>
        </p:spPr>
        <p:txBody>
          <a:bodyPr vert="horz" lIns="92229" tIns="46115" rIns="92229" bIns="4611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4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r">
              <a:defRPr sz="1200"/>
            </a:lvl1pPr>
          </a:lstStyle>
          <a:p>
            <a:fld id="{FC1018B4-28F9-43F3-8ACE-503A9AFA7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4094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818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03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533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3796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52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76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813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83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692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262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067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811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71DFBF8E-3392-4BE2-BCD6-659E8B47F3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1214280"/>
              </p:ext>
            </p:extLst>
          </p:nvPr>
        </p:nvGraphicFramePr>
        <p:xfrm>
          <a:off x="199429" y="4860032"/>
          <a:ext cx="6459142" cy="2969512"/>
        </p:xfrm>
        <a:graphic>
          <a:graphicData uri="http://schemas.openxmlformats.org/drawingml/2006/table">
            <a:tbl>
              <a:tblPr firstRow="1" firstCol="1" bandRow="1"/>
              <a:tblGrid>
                <a:gridCol w="379396">
                  <a:extLst>
                    <a:ext uri="{9D8B030D-6E8A-4147-A177-3AD203B41FA5}">
                      <a16:colId xmlns:a16="http://schemas.microsoft.com/office/drawing/2014/main" val="3706869917"/>
                    </a:ext>
                  </a:extLst>
                </a:gridCol>
                <a:gridCol w="1647429">
                  <a:extLst>
                    <a:ext uri="{9D8B030D-6E8A-4147-A177-3AD203B41FA5}">
                      <a16:colId xmlns:a16="http://schemas.microsoft.com/office/drawing/2014/main" val="4233872804"/>
                    </a:ext>
                  </a:extLst>
                </a:gridCol>
                <a:gridCol w="1392807">
                  <a:extLst>
                    <a:ext uri="{9D8B030D-6E8A-4147-A177-3AD203B41FA5}">
                      <a16:colId xmlns:a16="http://schemas.microsoft.com/office/drawing/2014/main" val="3433357176"/>
                    </a:ext>
                  </a:extLst>
                </a:gridCol>
                <a:gridCol w="1393531">
                  <a:extLst>
                    <a:ext uri="{9D8B030D-6E8A-4147-A177-3AD203B41FA5}">
                      <a16:colId xmlns:a16="http://schemas.microsoft.com/office/drawing/2014/main" val="133291675"/>
                    </a:ext>
                  </a:extLst>
                </a:gridCol>
                <a:gridCol w="1645979">
                  <a:extLst>
                    <a:ext uri="{9D8B030D-6E8A-4147-A177-3AD203B41FA5}">
                      <a16:colId xmlns:a16="http://schemas.microsoft.com/office/drawing/2014/main" val="1490622009"/>
                    </a:ext>
                  </a:extLst>
                </a:gridCol>
              </a:tblGrid>
              <a:tr h="259808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ositive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i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6243968"/>
                  </a:ext>
                </a:extLst>
              </a:tr>
              <a:tr h="386056">
                <a:tc gridSpan="2"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ecrosis type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3113554"/>
                  </a:ext>
                </a:extLst>
              </a:tr>
              <a:tr h="259808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altLang="ja-JP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All RCC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altLang="ja-JP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153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4313443"/>
                  </a:ext>
                </a:extLst>
              </a:tr>
              <a:tr h="386056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indent="6985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DN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9 (88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 (12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966097"/>
                  </a:ext>
                </a:extLst>
              </a:tr>
              <a:tr h="386056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indent="6985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GN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7 (98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 (2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6332382"/>
                  </a:ext>
                </a:extLst>
              </a:tr>
              <a:tr h="259808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ccRCC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only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335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4996496"/>
                  </a:ext>
                </a:extLst>
              </a:tr>
              <a:tr h="386056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indent="6985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DN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3 (89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 (12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8765248"/>
                  </a:ext>
                </a:extLst>
              </a:tr>
              <a:tr h="386056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indent="6985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GN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1 (97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 (3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4294803"/>
                  </a:ext>
                </a:extLst>
              </a:tr>
              <a:tr h="259808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R="344170" algn="l"/>
                      <a:r>
                        <a:rPr lang="en-US" sz="1400" i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values &lt;0.05 were considered significant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9729310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6E59EE92-8CF9-4CCA-9B99-B4239215F5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6960472"/>
              </p:ext>
            </p:extLst>
          </p:nvPr>
        </p:nvGraphicFramePr>
        <p:xfrm>
          <a:off x="199429" y="1115616"/>
          <a:ext cx="6459142" cy="2969512"/>
        </p:xfrm>
        <a:graphic>
          <a:graphicData uri="http://schemas.openxmlformats.org/drawingml/2006/table">
            <a:tbl>
              <a:tblPr firstRow="1" firstCol="1" bandRow="1"/>
              <a:tblGrid>
                <a:gridCol w="379396">
                  <a:extLst>
                    <a:ext uri="{9D8B030D-6E8A-4147-A177-3AD203B41FA5}">
                      <a16:colId xmlns:a16="http://schemas.microsoft.com/office/drawing/2014/main" val="3706869917"/>
                    </a:ext>
                  </a:extLst>
                </a:gridCol>
                <a:gridCol w="1647429">
                  <a:extLst>
                    <a:ext uri="{9D8B030D-6E8A-4147-A177-3AD203B41FA5}">
                      <a16:colId xmlns:a16="http://schemas.microsoft.com/office/drawing/2014/main" val="4233872804"/>
                    </a:ext>
                  </a:extLst>
                </a:gridCol>
                <a:gridCol w="1392807">
                  <a:extLst>
                    <a:ext uri="{9D8B030D-6E8A-4147-A177-3AD203B41FA5}">
                      <a16:colId xmlns:a16="http://schemas.microsoft.com/office/drawing/2014/main" val="3433357176"/>
                    </a:ext>
                  </a:extLst>
                </a:gridCol>
                <a:gridCol w="1393531">
                  <a:extLst>
                    <a:ext uri="{9D8B030D-6E8A-4147-A177-3AD203B41FA5}">
                      <a16:colId xmlns:a16="http://schemas.microsoft.com/office/drawing/2014/main" val="133291675"/>
                    </a:ext>
                  </a:extLst>
                </a:gridCol>
                <a:gridCol w="1645979">
                  <a:extLst>
                    <a:ext uri="{9D8B030D-6E8A-4147-A177-3AD203B41FA5}">
                      <a16:colId xmlns:a16="http://schemas.microsoft.com/office/drawing/2014/main" val="1490622009"/>
                    </a:ext>
                  </a:extLst>
                </a:gridCol>
              </a:tblGrid>
              <a:tr h="259808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ositive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i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6243968"/>
                  </a:ext>
                </a:extLst>
              </a:tr>
              <a:tr h="386056">
                <a:tc gridSpan="2"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ecrosis type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3113554"/>
                  </a:ext>
                </a:extLst>
              </a:tr>
              <a:tr h="259808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altLang="ja-JP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All RCC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altLang="ja-JP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4313443"/>
                  </a:ext>
                </a:extLst>
              </a:tr>
              <a:tr h="386056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indent="6985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DN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2 (97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 (3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966097"/>
                  </a:ext>
                </a:extLst>
              </a:tr>
              <a:tr h="386056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indent="6985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GN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7 (98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 (2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6332382"/>
                  </a:ext>
                </a:extLst>
              </a:tr>
              <a:tr h="259808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ccRCC</a:t>
                      </a: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only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altLang="ja-JP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4996496"/>
                  </a:ext>
                </a:extLst>
              </a:tr>
              <a:tr h="386056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indent="6985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DN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5 (96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 (4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8765248"/>
                  </a:ext>
                </a:extLst>
              </a:tr>
              <a:tr h="386056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indent="6985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GN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1 (97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 (3%)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4294803"/>
                  </a:ext>
                </a:extLst>
              </a:tr>
              <a:tr h="259808">
                <a:tc>
                  <a:txBody>
                    <a:bodyPr/>
                    <a:lstStyle/>
                    <a:p>
                      <a:pPr marR="344170" algn="l"/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4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R="344170" algn="l"/>
                      <a:r>
                        <a:rPr lang="en-US" sz="1400" i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values &lt;0.05 were considered significant</a:t>
                      </a:r>
                      <a:endParaRPr lang="ja-JP" sz="14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9729310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235A1CF-8559-4D7B-A308-7D193CCA3C79}"/>
              </a:ext>
            </a:extLst>
          </p:cNvPr>
          <p:cNvSpPr txBox="1"/>
          <p:nvPr/>
        </p:nvSpPr>
        <p:spPr>
          <a:xfrm>
            <a:off x="744" y="179512"/>
            <a:ext cx="6858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Table S3. Association of necrosis type and ZEB1 expression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within areas around the necrotic foci (A) </a:t>
            </a:r>
            <a:r>
              <a:rPr lang="en-US" altLang="ja-JP" sz="1400" b="1" kern="100" dirty="0">
                <a:solidFill>
                  <a:srgbClr val="000000"/>
                </a:solidFill>
                <a:ea typeface="メイリオ" panose="020B0604030504040204" pitchFamily="50" charset="-128"/>
                <a:cs typeface="Helvetica" panose="020B0604020202020204" pitchFamily="34" charset="0"/>
              </a:rPr>
              <a:t>or</a:t>
            </a:r>
            <a:r>
              <a:rPr kumimoji="1" lang="en-US" altLang="ja-JP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 far from the necrotic foci (B)</a:t>
            </a:r>
            <a:endParaRPr kumimoji="1" lang="en-US" altLang="ja-JP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HG明朝E"/>
              <a:cs typeface="Helvetica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35D8F28-60E2-4105-A130-A55D1E08AD80}"/>
              </a:ext>
            </a:extLst>
          </p:cNvPr>
          <p:cNvSpPr txBox="1"/>
          <p:nvPr/>
        </p:nvSpPr>
        <p:spPr>
          <a:xfrm>
            <a:off x="199429" y="827584"/>
            <a:ext cx="490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cs typeface="Times New Roman" pitchFamily="18" charset="0"/>
              </a:rPr>
              <a:t>(A)</a:t>
            </a:r>
            <a:endParaRPr lang="ja-JP" altLang="ja-JP" sz="1400" b="1" dirty="0">
              <a:cs typeface="Times New Roman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3CE1E2A-6B7F-4858-9BC3-135FF5313CA0}"/>
              </a:ext>
            </a:extLst>
          </p:cNvPr>
          <p:cNvSpPr txBox="1"/>
          <p:nvPr/>
        </p:nvSpPr>
        <p:spPr>
          <a:xfrm>
            <a:off x="199429" y="4572000"/>
            <a:ext cx="490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cs typeface="Times New Roman" pitchFamily="18" charset="0"/>
              </a:rPr>
              <a:t>(B)</a:t>
            </a:r>
            <a:endParaRPr lang="ja-JP" altLang="ja-JP" sz="1400" b="1" dirty="0">
              <a:cs typeface="Times New Roman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B3BE5F2-9304-49F7-A34F-CBF367B808A9}"/>
              </a:ext>
            </a:extLst>
          </p:cNvPr>
          <p:cNvSpPr txBox="1"/>
          <p:nvPr/>
        </p:nvSpPr>
        <p:spPr>
          <a:xfrm>
            <a:off x="0" y="8117576"/>
            <a:ext cx="6858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Abbreviations: </a:t>
            </a:r>
            <a:r>
              <a:rPr kumimoji="1" lang="en-US" altLang="ja-JP" sz="1400" dirty="0" err="1"/>
              <a:t>ccRCC</a:t>
            </a:r>
            <a:r>
              <a:rPr kumimoji="1" lang="en-US" altLang="ja-JP" sz="1400" dirty="0"/>
              <a:t>, clear cell RCC; DN, dirty necrosis; GN, ghost necrosis; RCC, renal cell carcinoma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695093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4">
      <a:majorFont>
        <a:latin typeface="Times New Roman"/>
        <a:ea typeface="HGｺﾞｼｯｸM"/>
        <a:cs typeface=""/>
      </a:majorFont>
      <a:minorFont>
        <a:latin typeface="Times New Roman"/>
        <a:ea typeface="HG明朝E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92</TotalTime>
  <Words>205</Words>
  <Application>Microsoft Office PowerPoint</Application>
  <PresentationFormat>画面に合わせる (4:3)</PresentationFormat>
  <Paragraphs>8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明朝</vt:lpstr>
      <vt:lpstr>Arial</vt:lpstr>
      <vt:lpstr>Calibri</vt:lpstr>
      <vt:lpstr>Times New Roman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</dc:creator>
  <cp:lastModifiedBy>崇史 黒江</cp:lastModifiedBy>
  <cp:revision>591</cp:revision>
  <cp:lastPrinted>2021-05-31T23:33:41Z</cp:lastPrinted>
  <dcterms:created xsi:type="dcterms:W3CDTF">2016-07-10T13:11:22Z</dcterms:created>
  <dcterms:modified xsi:type="dcterms:W3CDTF">2022-02-03T03:45:08Z</dcterms:modified>
</cp:coreProperties>
</file>